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EB8F68-1A20-4114-8206-3421AB88362D}" v="3" dt="2025-03-11T10:57:51.2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4" autoAdjust="0"/>
    <p:restoredTop sz="94660"/>
  </p:normalViewPr>
  <p:slideViewPr>
    <p:cSldViewPr snapToGrid="0">
      <p:cViewPr varScale="1">
        <p:scale>
          <a:sx n="98" d="100"/>
          <a:sy n="98" d="100"/>
        </p:scale>
        <p:origin x="108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kira Ouchi" userId="3da18b59e1d60f73" providerId="LiveId" clId="{23195B23-7B49-4D9E-BEEB-96185F9B7029}"/>
    <pc:docChg chg="custSel modSld">
      <pc:chgData name="Akira Ouchi" userId="3da18b59e1d60f73" providerId="LiveId" clId="{23195B23-7B49-4D9E-BEEB-96185F9B7029}" dt="2025-03-05T22:21:24.470" v="23"/>
      <pc:docMkLst>
        <pc:docMk/>
      </pc:docMkLst>
      <pc:sldChg chg="addSp delSp modSp mod">
        <pc:chgData name="Akira Ouchi" userId="3da18b59e1d60f73" providerId="LiveId" clId="{23195B23-7B49-4D9E-BEEB-96185F9B7029}" dt="2025-03-05T22:21:24.470" v="23"/>
        <pc:sldMkLst>
          <pc:docMk/>
          <pc:sldMk cId="430399478" sldId="316"/>
        </pc:sldMkLst>
      </pc:sldChg>
    </pc:docChg>
  </pc:docChgLst>
  <pc:docChgLst>
    <pc:chgData name="Akira Ouchi" userId="3da18b59e1d60f73" providerId="LiveId" clId="{A3F497D4-63CF-4D66-9099-B37D8EDE2789}"/>
    <pc:docChg chg="delSld modSld">
      <pc:chgData name="Akira Ouchi" userId="3da18b59e1d60f73" providerId="LiveId" clId="{A3F497D4-63CF-4D66-9099-B37D8EDE2789}" dt="2024-12-12T14:55:13.288" v="53" actId="2696"/>
      <pc:docMkLst>
        <pc:docMk/>
      </pc:docMkLst>
      <pc:sldChg chg="modSp mod">
        <pc:chgData name="Akira Ouchi" userId="3da18b59e1d60f73" providerId="LiveId" clId="{A3F497D4-63CF-4D66-9099-B37D8EDE2789}" dt="2024-08-27T13:33:12.929" v="44" actId="6549"/>
        <pc:sldMkLst>
          <pc:docMk/>
          <pc:sldMk cId="430399478" sldId="316"/>
        </pc:sldMkLst>
      </pc:sldChg>
      <pc:sldChg chg="modSp mod">
        <pc:chgData name="Akira Ouchi" userId="3da18b59e1d60f73" providerId="LiveId" clId="{A3F497D4-63CF-4D66-9099-B37D8EDE2789}" dt="2024-08-27T13:33:05.173" v="36" actId="6549"/>
        <pc:sldMkLst>
          <pc:docMk/>
          <pc:sldMk cId="2673606678" sldId="317"/>
        </pc:sldMkLst>
      </pc:sldChg>
      <pc:sldChg chg="modSp mod">
        <pc:chgData name="Akira Ouchi" userId="3da18b59e1d60f73" providerId="LiveId" clId="{A3F497D4-63CF-4D66-9099-B37D8EDE2789}" dt="2024-08-27T13:33:09.348" v="40" actId="6549"/>
        <pc:sldMkLst>
          <pc:docMk/>
          <pc:sldMk cId="3170936020" sldId="319"/>
        </pc:sldMkLst>
      </pc:sldChg>
      <pc:sldChg chg="modSp mod">
        <pc:chgData name="Akira Ouchi" userId="3da18b59e1d60f73" providerId="LiveId" clId="{A3F497D4-63CF-4D66-9099-B37D8EDE2789}" dt="2024-08-27T13:33:00.259" v="32" actId="20577"/>
        <pc:sldMkLst>
          <pc:docMk/>
          <pc:sldMk cId="36269307" sldId="320"/>
        </pc:sldMkLst>
      </pc:sldChg>
      <pc:sldChg chg="modSp mod">
        <pc:chgData name="Akira Ouchi" userId="3da18b59e1d60f73" providerId="LiveId" clId="{A3F497D4-63CF-4D66-9099-B37D8EDE2789}" dt="2024-08-27T13:33:20.211" v="52" actId="6549"/>
        <pc:sldMkLst>
          <pc:docMk/>
          <pc:sldMk cId="484831294" sldId="323"/>
        </pc:sldMkLst>
      </pc:sldChg>
      <pc:sldChg chg="modSp mod">
        <pc:chgData name="Akira Ouchi" userId="3da18b59e1d60f73" providerId="LiveId" clId="{A3F497D4-63CF-4D66-9099-B37D8EDE2789}" dt="2024-08-24T04:32:35.232" v="0" actId="1582"/>
        <pc:sldMkLst>
          <pc:docMk/>
          <pc:sldMk cId="3526519749" sldId="334"/>
        </pc:sldMkLst>
      </pc:sldChg>
      <pc:sldChg chg="modSp mod">
        <pc:chgData name="Akira Ouchi" userId="3da18b59e1d60f73" providerId="LiveId" clId="{A3F497D4-63CF-4D66-9099-B37D8EDE2789}" dt="2024-08-27T13:33:16.807" v="48" actId="6549"/>
        <pc:sldMkLst>
          <pc:docMk/>
          <pc:sldMk cId="2209211313" sldId="336"/>
        </pc:sldMkLst>
      </pc:sldChg>
      <pc:sldChg chg="del">
        <pc:chgData name="Akira Ouchi" userId="3da18b59e1d60f73" providerId="LiveId" clId="{A3F497D4-63CF-4D66-9099-B37D8EDE2789}" dt="2024-12-12T14:55:13.288" v="53" actId="2696"/>
        <pc:sldMkLst>
          <pc:docMk/>
          <pc:sldMk cId="2657868269" sldId="337"/>
        </pc:sldMkLst>
      </pc:sldChg>
    </pc:docChg>
  </pc:docChgLst>
  <pc:docChgLst>
    <pc:chgData name="Akira Ouchi" userId="3da18b59e1d60f73" providerId="LiveId" clId="{7665C00C-04DE-44F7-ADEF-2FA3354DBB51}"/>
    <pc:docChg chg="undo custSel addSld delSld modSld sldOrd">
      <pc:chgData name="Akira Ouchi" userId="3da18b59e1d60f73" providerId="LiveId" clId="{7665C00C-04DE-44F7-ADEF-2FA3354DBB51}" dt="2024-08-26T06:23:38.024" v="726" actId="20577"/>
      <pc:docMkLst>
        <pc:docMk/>
      </pc:docMkLst>
      <pc:sldChg chg="addSp delSp modSp mod">
        <pc:chgData name="Akira Ouchi" userId="3da18b59e1d60f73" providerId="LiveId" clId="{7665C00C-04DE-44F7-ADEF-2FA3354DBB51}" dt="2024-08-24T02:36:40.036" v="257" actId="404"/>
        <pc:sldMkLst>
          <pc:docMk/>
          <pc:sldMk cId="978796953" sldId="256"/>
        </pc:sldMkLst>
      </pc:sldChg>
      <pc:sldChg chg="new del">
        <pc:chgData name="Akira Ouchi" userId="3da18b59e1d60f73" providerId="LiveId" clId="{7665C00C-04DE-44F7-ADEF-2FA3354DBB51}" dt="2024-08-24T02:24:40.428" v="108" actId="2696"/>
        <pc:sldMkLst>
          <pc:docMk/>
          <pc:sldMk cId="1096343627" sldId="257"/>
        </pc:sldMkLst>
      </pc:sldChg>
      <pc:sldChg chg="addSp delSp modSp add mod">
        <pc:chgData name="Akira Ouchi" userId="3da18b59e1d60f73" providerId="LiveId" clId="{7665C00C-04DE-44F7-ADEF-2FA3354DBB51}" dt="2024-08-24T02:45:46.382" v="458" actId="20577"/>
        <pc:sldMkLst>
          <pc:docMk/>
          <pc:sldMk cId="430399478" sldId="316"/>
        </pc:sldMkLst>
      </pc:sldChg>
      <pc:sldChg chg="addSp delSp modSp add mod">
        <pc:chgData name="Akira Ouchi" userId="3da18b59e1d60f73" providerId="LiveId" clId="{7665C00C-04DE-44F7-ADEF-2FA3354DBB51}" dt="2024-08-24T02:54:25.306" v="706" actId="20577"/>
        <pc:sldMkLst>
          <pc:docMk/>
          <pc:sldMk cId="2673606678" sldId="317"/>
        </pc:sldMkLst>
      </pc:sldChg>
      <pc:sldChg chg="addSp delSp modSp add mod ord">
        <pc:chgData name="Akira Ouchi" userId="3da18b59e1d60f73" providerId="LiveId" clId="{7665C00C-04DE-44F7-ADEF-2FA3354DBB51}" dt="2024-08-24T02:50:59.062" v="661"/>
        <pc:sldMkLst>
          <pc:docMk/>
          <pc:sldMk cId="3170936020" sldId="319"/>
        </pc:sldMkLst>
      </pc:sldChg>
      <pc:sldChg chg="addSp delSp modSp add mod">
        <pc:chgData name="Akira Ouchi" userId="3da18b59e1d60f73" providerId="LiveId" clId="{7665C00C-04DE-44F7-ADEF-2FA3354DBB51}" dt="2024-08-24T02:54:12.307" v="693" actId="20577"/>
        <pc:sldMkLst>
          <pc:docMk/>
          <pc:sldMk cId="36269307" sldId="320"/>
        </pc:sldMkLst>
      </pc:sldChg>
      <pc:sldChg chg="addSp delSp modSp add mod">
        <pc:chgData name="Akira Ouchi" userId="3da18b59e1d60f73" providerId="LiveId" clId="{7665C00C-04DE-44F7-ADEF-2FA3354DBB51}" dt="2024-08-24T02:52:48.433" v="688" actId="1076"/>
        <pc:sldMkLst>
          <pc:docMk/>
          <pc:sldMk cId="484831294" sldId="323"/>
        </pc:sldMkLst>
      </pc:sldChg>
      <pc:sldChg chg="addSp delSp modSp add mod">
        <pc:chgData name="Akira Ouchi" userId="3da18b59e1d60f73" providerId="LiveId" clId="{7665C00C-04DE-44F7-ADEF-2FA3354DBB51}" dt="2024-08-26T06:23:38.024" v="726" actId="20577"/>
        <pc:sldMkLst>
          <pc:docMk/>
          <pc:sldMk cId="3526519749" sldId="334"/>
        </pc:sldMkLst>
      </pc:sldChg>
      <pc:sldChg chg="delSp new del mod">
        <pc:chgData name="Akira Ouchi" userId="3da18b59e1d60f73" providerId="LiveId" clId="{7665C00C-04DE-44F7-ADEF-2FA3354DBB51}" dt="2024-08-24T02:31:16.717" v="120" actId="2696"/>
        <pc:sldMkLst>
          <pc:docMk/>
          <pc:sldMk cId="2945271688" sldId="335"/>
        </pc:sldMkLst>
      </pc:sldChg>
      <pc:sldChg chg="addSp delSp modSp new mod">
        <pc:chgData name="Akira Ouchi" userId="3da18b59e1d60f73" providerId="LiveId" clId="{7665C00C-04DE-44F7-ADEF-2FA3354DBB51}" dt="2024-08-24T02:50:30.617" v="649" actId="20577"/>
        <pc:sldMkLst>
          <pc:docMk/>
          <pc:sldMk cId="2209211313" sldId="336"/>
        </pc:sldMkLst>
      </pc:sldChg>
      <pc:sldChg chg="new">
        <pc:chgData name="Akira Ouchi" userId="3da18b59e1d60f73" providerId="LiveId" clId="{7665C00C-04DE-44F7-ADEF-2FA3354DBB51}" dt="2024-08-24T02:29:22.601" v="115" actId="680"/>
        <pc:sldMkLst>
          <pc:docMk/>
          <pc:sldMk cId="2657868269" sldId="337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1302361765" sldId="338"/>
        </pc:sldMkLst>
      </pc:sldChg>
      <pc:sldChg chg="new del">
        <pc:chgData name="Akira Ouchi" userId="3da18b59e1d60f73" providerId="LiveId" clId="{7665C00C-04DE-44F7-ADEF-2FA3354DBB51}" dt="2024-08-24T02:29:49.276" v="119" actId="47"/>
        <pc:sldMkLst>
          <pc:docMk/>
          <pc:sldMk cId="2657678063" sldId="338"/>
        </pc:sldMkLst>
      </pc:sldChg>
      <pc:sldChg chg="add del">
        <pc:chgData name="Akira Ouchi" userId="3da18b59e1d60f73" providerId="LiveId" clId="{7665C00C-04DE-44F7-ADEF-2FA3354DBB51}" dt="2024-08-24T02:31:34.938" v="123"/>
        <pc:sldMkLst>
          <pc:docMk/>
          <pc:sldMk cId="3209479371" sldId="339"/>
        </pc:sldMkLst>
      </pc:sldChg>
    </pc:docChg>
  </pc:docChgLst>
  <pc:docChgLst>
    <pc:chgData name="Akira Ouchi" userId="3da18b59e1d60f73" providerId="LiveId" clId="{7AEB8F68-1A20-4114-8206-3421AB88362D}"/>
    <pc:docChg chg="undo custSel modSld">
      <pc:chgData name="Akira Ouchi" userId="3da18b59e1d60f73" providerId="LiveId" clId="{7AEB8F68-1A20-4114-8206-3421AB88362D}" dt="2025-03-11T12:01:39.824" v="7" actId="2711"/>
      <pc:docMkLst>
        <pc:docMk/>
      </pc:docMkLst>
      <pc:sldChg chg="addSp delSp modSp mod">
        <pc:chgData name="Akira Ouchi" userId="3da18b59e1d60f73" providerId="LiveId" clId="{7AEB8F68-1A20-4114-8206-3421AB88362D}" dt="2025-03-11T12:01:39.824" v="7" actId="2711"/>
        <pc:sldMkLst>
          <pc:docMk/>
          <pc:sldMk cId="430399478" sldId="316"/>
        </pc:sldMkLst>
        <pc:spChg chg="add mod">
          <ac:chgData name="Akira Ouchi" userId="3da18b59e1d60f73" providerId="LiveId" clId="{7AEB8F68-1A20-4114-8206-3421AB88362D}" dt="2025-03-11T10:57:38.251" v="1"/>
          <ac:spMkLst>
            <pc:docMk/>
            <pc:sldMk cId="430399478" sldId="316"/>
            <ac:spMk id="2" creationId="{968ACA86-E2E2-E106-1CBE-5220B5BCFC08}"/>
          </ac:spMkLst>
        </pc:spChg>
        <pc:spChg chg="add del">
          <ac:chgData name="Akira Ouchi" userId="3da18b59e1d60f73" providerId="LiveId" clId="{7AEB8F68-1A20-4114-8206-3421AB88362D}" dt="2025-03-11T10:57:49.988" v="3" actId="478"/>
          <ac:spMkLst>
            <pc:docMk/>
            <pc:sldMk cId="430399478" sldId="316"/>
            <ac:spMk id="3" creationId="{497A442C-FD38-9D52-BDED-5D1E2C316398}"/>
          </ac:spMkLst>
        </pc:spChg>
        <pc:spChg chg="add del">
          <ac:chgData name="Akira Ouchi" userId="3da18b59e1d60f73" providerId="LiveId" clId="{7AEB8F68-1A20-4114-8206-3421AB88362D}" dt="2025-03-11T10:57:49.988" v="3" actId="478"/>
          <ac:spMkLst>
            <pc:docMk/>
            <pc:sldMk cId="430399478" sldId="316"/>
            <ac:spMk id="4" creationId="{AB6A85FF-2D67-FDD6-4352-5E941BB17106}"/>
          </ac:spMkLst>
        </pc:spChg>
        <pc:spChg chg="add del">
          <ac:chgData name="Akira Ouchi" userId="3da18b59e1d60f73" providerId="LiveId" clId="{7AEB8F68-1A20-4114-8206-3421AB88362D}" dt="2025-03-11T10:57:49.988" v="3" actId="478"/>
          <ac:spMkLst>
            <pc:docMk/>
            <pc:sldMk cId="430399478" sldId="316"/>
            <ac:spMk id="5" creationId="{F2F78FAD-1BDA-E087-3968-5E896372618E}"/>
          </ac:spMkLst>
        </pc:spChg>
        <pc:spChg chg="add mod">
          <ac:chgData name="Akira Ouchi" userId="3da18b59e1d60f73" providerId="LiveId" clId="{7AEB8F68-1A20-4114-8206-3421AB88362D}" dt="2025-03-11T10:57:38.251" v="1"/>
          <ac:spMkLst>
            <pc:docMk/>
            <pc:sldMk cId="430399478" sldId="316"/>
            <ac:spMk id="6" creationId="{D5FCAB0A-DA7D-7698-27C3-942AF18A4638}"/>
          </ac:spMkLst>
        </pc:spChg>
        <pc:spChg chg="add mod">
          <ac:chgData name="Akira Ouchi" userId="3da18b59e1d60f73" providerId="LiveId" clId="{7AEB8F68-1A20-4114-8206-3421AB88362D}" dt="2025-03-11T10:57:38.251" v="1"/>
          <ac:spMkLst>
            <pc:docMk/>
            <pc:sldMk cId="430399478" sldId="316"/>
            <ac:spMk id="7" creationId="{685EF6CB-38AE-959B-32D6-0A7BADA6DE98}"/>
          </ac:spMkLst>
        </pc:spChg>
        <pc:spChg chg="mod">
          <ac:chgData name="Akira Ouchi" userId="3da18b59e1d60f73" providerId="LiveId" clId="{7AEB8F68-1A20-4114-8206-3421AB88362D}" dt="2025-03-11T12:01:39.824" v="7" actId="2711"/>
          <ac:spMkLst>
            <pc:docMk/>
            <pc:sldMk cId="430399478" sldId="316"/>
            <ac:spMk id="9" creationId="{ED959D16-1079-99D4-E1A3-CE4317D5DDB8}"/>
          </ac:spMkLst>
        </pc:spChg>
        <pc:spChg chg="add mod">
          <ac:chgData name="Akira Ouchi" userId="3da18b59e1d60f73" providerId="LiveId" clId="{7AEB8F68-1A20-4114-8206-3421AB88362D}" dt="2025-03-11T10:57:38.251" v="1"/>
          <ac:spMkLst>
            <pc:docMk/>
            <pc:sldMk cId="430399478" sldId="316"/>
            <ac:spMk id="15" creationId="{6F624453-9F1D-6915-BFE4-F1008AB6FE33}"/>
          </ac:spMkLst>
        </pc:spChg>
        <pc:spChg chg="add mod">
          <ac:chgData name="Akira Ouchi" userId="3da18b59e1d60f73" providerId="LiveId" clId="{7AEB8F68-1A20-4114-8206-3421AB88362D}" dt="2025-03-11T10:57:55.743" v="6" actId="1036"/>
          <ac:spMkLst>
            <pc:docMk/>
            <pc:sldMk cId="430399478" sldId="316"/>
            <ac:spMk id="16" creationId="{94F0A2B8-FA26-2942-667E-034E0E99872E}"/>
          </ac:spMkLst>
        </pc:spChg>
        <pc:spChg chg="add del">
          <ac:chgData name="Akira Ouchi" userId="3da18b59e1d60f73" providerId="LiveId" clId="{7AEB8F68-1A20-4114-8206-3421AB88362D}" dt="2025-03-11T10:57:49.988" v="3" actId="478"/>
          <ac:spMkLst>
            <pc:docMk/>
            <pc:sldMk cId="430399478" sldId="316"/>
            <ac:spMk id="17" creationId="{A0E5FB10-E98C-EBA1-909E-6D20EE659BC9}"/>
          </ac:spMkLst>
        </pc:spChg>
        <pc:spChg chg="add mod">
          <ac:chgData name="Akira Ouchi" userId="3da18b59e1d60f73" providerId="LiveId" clId="{7AEB8F68-1A20-4114-8206-3421AB88362D}" dt="2025-03-11T10:57:55.743" v="6" actId="1036"/>
          <ac:spMkLst>
            <pc:docMk/>
            <pc:sldMk cId="430399478" sldId="316"/>
            <ac:spMk id="18" creationId="{A3F4D9DD-ED1E-725B-A0C5-87676783FDCD}"/>
          </ac:spMkLst>
        </pc:spChg>
        <pc:spChg chg="add mod">
          <ac:chgData name="Akira Ouchi" userId="3da18b59e1d60f73" providerId="LiveId" clId="{7AEB8F68-1A20-4114-8206-3421AB88362D}" dt="2025-03-11T10:57:55.743" v="6" actId="1036"/>
          <ac:spMkLst>
            <pc:docMk/>
            <pc:sldMk cId="430399478" sldId="316"/>
            <ac:spMk id="19" creationId="{12A976BA-D3E9-837A-61D3-7F094DA206A4}"/>
          </ac:spMkLst>
        </pc:spChg>
        <pc:spChg chg="add mod">
          <ac:chgData name="Akira Ouchi" userId="3da18b59e1d60f73" providerId="LiveId" clId="{7AEB8F68-1A20-4114-8206-3421AB88362D}" dt="2025-03-11T10:57:55.743" v="6" actId="1036"/>
          <ac:spMkLst>
            <pc:docMk/>
            <pc:sldMk cId="430399478" sldId="316"/>
            <ac:spMk id="23" creationId="{DA109CD3-BB2F-0D5A-AB25-59EA81C202BA}"/>
          </ac:spMkLst>
        </pc:spChg>
        <pc:picChg chg="add mod">
          <ac:chgData name="Akira Ouchi" userId="3da18b59e1d60f73" providerId="LiveId" clId="{7AEB8F68-1A20-4114-8206-3421AB88362D}" dt="2025-03-11T10:57:38.251" v="1"/>
          <ac:picMkLst>
            <pc:docMk/>
            <pc:sldMk cId="430399478" sldId="316"/>
            <ac:picMk id="8" creationId="{2C300279-4CDC-AF07-08A7-E4E55044A547}"/>
          </ac:picMkLst>
        </pc:picChg>
        <pc:picChg chg="add del">
          <ac:chgData name="Akira Ouchi" userId="3da18b59e1d60f73" providerId="LiveId" clId="{7AEB8F68-1A20-4114-8206-3421AB88362D}" dt="2025-03-11T10:57:49.988" v="3" actId="478"/>
          <ac:picMkLst>
            <pc:docMk/>
            <pc:sldMk cId="430399478" sldId="316"/>
            <ac:picMk id="10" creationId="{B66C068F-20FA-510A-D61D-725A72CBEE6C}"/>
          </ac:picMkLst>
        </pc:picChg>
        <pc:picChg chg="add del">
          <ac:chgData name="Akira Ouchi" userId="3da18b59e1d60f73" providerId="LiveId" clId="{7AEB8F68-1A20-4114-8206-3421AB88362D}" dt="2025-03-11T10:57:49.988" v="3" actId="478"/>
          <ac:picMkLst>
            <pc:docMk/>
            <pc:sldMk cId="430399478" sldId="316"/>
            <ac:picMk id="11" creationId="{E7C98FB4-BAC1-0130-1AAE-B3D630EA812D}"/>
          </ac:picMkLst>
        </pc:picChg>
        <pc:picChg chg="add del">
          <ac:chgData name="Akira Ouchi" userId="3da18b59e1d60f73" providerId="LiveId" clId="{7AEB8F68-1A20-4114-8206-3421AB88362D}" dt="2025-03-11T10:57:49.988" v="3" actId="478"/>
          <ac:picMkLst>
            <pc:docMk/>
            <pc:sldMk cId="430399478" sldId="316"/>
            <ac:picMk id="12" creationId="{3850779E-BE6B-D620-0CA8-358E1573431B}"/>
          </ac:picMkLst>
        </pc:picChg>
        <pc:picChg chg="add mod">
          <ac:chgData name="Akira Ouchi" userId="3da18b59e1d60f73" providerId="LiveId" clId="{7AEB8F68-1A20-4114-8206-3421AB88362D}" dt="2025-03-11T10:57:38.251" v="1"/>
          <ac:picMkLst>
            <pc:docMk/>
            <pc:sldMk cId="430399478" sldId="316"/>
            <ac:picMk id="13" creationId="{BE55E106-CECD-C0D3-2DBB-3575E9D0D131}"/>
          </ac:picMkLst>
        </pc:picChg>
        <pc:picChg chg="add mod">
          <ac:chgData name="Akira Ouchi" userId="3da18b59e1d60f73" providerId="LiveId" clId="{7AEB8F68-1A20-4114-8206-3421AB88362D}" dt="2025-03-11T10:57:38.251" v="1"/>
          <ac:picMkLst>
            <pc:docMk/>
            <pc:sldMk cId="430399478" sldId="316"/>
            <ac:picMk id="14" creationId="{2F5B88E4-10CD-DDE2-3298-2D1631183D21}"/>
          </ac:picMkLst>
        </pc:picChg>
        <pc:picChg chg="add mod">
          <ac:chgData name="Akira Ouchi" userId="3da18b59e1d60f73" providerId="LiveId" clId="{7AEB8F68-1A20-4114-8206-3421AB88362D}" dt="2025-03-11T10:57:55.743" v="6" actId="1036"/>
          <ac:picMkLst>
            <pc:docMk/>
            <pc:sldMk cId="430399478" sldId="316"/>
            <ac:picMk id="20" creationId="{D9D15A3B-33B2-3177-0721-5CC9F603F8F0}"/>
          </ac:picMkLst>
        </pc:picChg>
        <pc:picChg chg="add mod">
          <ac:chgData name="Akira Ouchi" userId="3da18b59e1d60f73" providerId="LiveId" clId="{7AEB8F68-1A20-4114-8206-3421AB88362D}" dt="2025-03-11T10:57:55.743" v="6" actId="1036"/>
          <ac:picMkLst>
            <pc:docMk/>
            <pc:sldMk cId="430399478" sldId="316"/>
            <ac:picMk id="21" creationId="{1A0E6759-B046-1BEB-7CD8-5E2CB7C9B8E8}"/>
          </ac:picMkLst>
        </pc:picChg>
        <pc:picChg chg="add mod">
          <ac:chgData name="Akira Ouchi" userId="3da18b59e1d60f73" providerId="LiveId" clId="{7AEB8F68-1A20-4114-8206-3421AB88362D}" dt="2025-03-11T10:57:55.743" v="6" actId="1036"/>
          <ac:picMkLst>
            <pc:docMk/>
            <pc:sldMk cId="430399478" sldId="316"/>
            <ac:picMk id="22" creationId="{F818365B-7D12-A1F7-CA62-3D5F50F74A58}"/>
          </ac:picMkLst>
        </pc:picChg>
      </pc:sldChg>
    </pc:docChg>
  </pc:docChgLst>
  <pc:docChgLst>
    <pc:chgData name="Akira Ouchi" userId="3da18b59e1d60f73" providerId="LiveId" clId="{CED4D1B1-B03B-4007-81C8-E249B2FC1E6E}"/>
    <pc:docChg chg="delSld">
      <pc:chgData name="Akira Ouchi" userId="3da18b59e1d60f73" providerId="LiveId" clId="{CED4D1B1-B03B-4007-81C8-E249B2FC1E6E}" dt="2024-12-24T11:24:43.245" v="0" actId="2696"/>
      <pc:docMkLst>
        <pc:docMk/>
      </pc:docMkLst>
      <pc:sldChg chg="del">
        <pc:chgData name="Akira Ouchi" userId="3da18b59e1d60f73" providerId="LiveId" clId="{CED4D1B1-B03B-4007-81C8-E249B2FC1E6E}" dt="2024-12-24T11:24:43.245" v="0" actId="2696"/>
        <pc:sldMkLst>
          <pc:docMk/>
          <pc:sldMk cId="2673606678" sldId="317"/>
        </pc:sldMkLst>
      </pc:sldChg>
      <pc:sldChg chg="del">
        <pc:chgData name="Akira Ouchi" userId="3da18b59e1d60f73" providerId="LiveId" clId="{CED4D1B1-B03B-4007-81C8-E249B2FC1E6E}" dt="2024-12-24T11:24:43.245" v="0" actId="2696"/>
        <pc:sldMkLst>
          <pc:docMk/>
          <pc:sldMk cId="3170936020" sldId="319"/>
        </pc:sldMkLst>
      </pc:sldChg>
      <pc:sldChg chg="del">
        <pc:chgData name="Akira Ouchi" userId="3da18b59e1d60f73" providerId="LiveId" clId="{CED4D1B1-B03B-4007-81C8-E249B2FC1E6E}" dt="2024-12-24T11:24:43.245" v="0" actId="2696"/>
        <pc:sldMkLst>
          <pc:docMk/>
          <pc:sldMk cId="36269307" sldId="320"/>
        </pc:sldMkLst>
      </pc:sldChg>
    </pc:docChg>
  </pc:docChgLst>
  <pc:docChgLst>
    <pc:chgData name="Akira Ouchi" userId="3da18b59e1d60f73" providerId="LiveId" clId="{27AAABF1-9238-4101-B67E-D5B1596E4369}"/>
    <pc:docChg chg="undo custSel modSld">
      <pc:chgData name="Akira Ouchi" userId="3da18b59e1d60f73" providerId="LiveId" clId="{27AAABF1-9238-4101-B67E-D5B1596E4369}" dt="2024-11-06T05:58:48.571" v="49"/>
      <pc:docMkLst>
        <pc:docMk/>
      </pc:docMkLst>
      <pc:sldChg chg="addSp delSp modSp mod">
        <pc:chgData name="Akira Ouchi" userId="3da18b59e1d60f73" providerId="LiveId" clId="{27AAABF1-9238-4101-B67E-D5B1596E4369}" dt="2024-11-06T05:53:53.497" v="16" actId="478"/>
        <pc:sldMkLst>
          <pc:docMk/>
          <pc:sldMk cId="430399478" sldId="316"/>
        </pc:sldMkLst>
      </pc:sldChg>
      <pc:sldChg chg="addSp delSp modSp mod">
        <pc:chgData name="Akira Ouchi" userId="3da18b59e1d60f73" providerId="LiveId" clId="{27AAABF1-9238-4101-B67E-D5B1596E4369}" dt="2024-11-06T05:57:59.089" v="37"/>
        <pc:sldMkLst>
          <pc:docMk/>
          <pc:sldMk cId="2673606678" sldId="317"/>
        </pc:sldMkLst>
      </pc:sldChg>
      <pc:sldChg chg="addSp delSp modSp mod">
        <pc:chgData name="Akira Ouchi" userId="3da18b59e1d60f73" providerId="LiveId" clId="{27AAABF1-9238-4101-B67E-D5B1596E4369}" dt="2024-11-06T05:54:15.267" v="21"/>
        <pc:sldMkLst>
          <pc:docMk/>
          <pc:sldMk cId="3170936020" sldId="319"/>
        </pc:sldMkLst>
      </pc:sldChg>
      <pc:sldChg chg="addSp delSp modSp mod">
        <pc:chgData name="Akira Ouchi" userId="3da18b59e1d60f73" providerId="LiveId" clId="{27AAABF1-9238-4101-B67E-D5B1596E4369}" dt="2024-11-06T05:55:31.693" v="26"/>
        <pc:sldMkLst>
          <pc:docMk/>
          <pc:sldMk cId="36269307" sldId="320"/>
        </pc:sldMkLst>
      </pc:sldChg>
      <pc:sldChg chg="addSp delSp modSp mod">
        <pc:chgData name="Akira Ouchi" userId="3da18b59e1d60f73" providerId="LiveId" clId="{27AAABF1-9238-4101-B67E-D5B1596E4369}" dt="2024-11-06T05:52:09.154" v="6"/>
        <pc:sldMkLst>
          <pc:docMk/>
          <pc:sldMk cId="484831294" sldId="323"/>
        </pc:sldMkLst>
      </pc:sldChg>
      <pc:sldChg chg="addSp delSp modSp mod">
        <pc:chgData name="Akira Ouchi" userId="3da18b59e1d60f73" providerId="LiveId" clId="{27AAABF1-9238-4101-B67E-D5B1596E4369}" dt="2024-11-06T05:58:48.571" v="49"/>
        <pc:sldMkLst>
          <pc:docMk/>
          <pc:sldMk cId="2209211313" sldId="336"/>
        </pc:sldMkLst>
      </pc:sldChg>
    </pc:docChg>
  </pc:docChgLst>
  <pc:docChgLst>
    <pc:chgData name="Akira Ouchi" userId="3da18b59e1d60f73" providerId="LiveId" clId="{C99AD3AB-F44A-4646-8D6E-4C0A93682AEC}"/>
    <pc:docChg chg="modSld">
      <pc:chgData name="Akira Ouchi" userId="3da18b59e1d60f73" providerId="LiveId" clId="{C99AD3AB-F44A-4646-8D6E-4C0A93682AEC}" dt="2024-07-12T05:58:51.263" v="0" actId="20577"/>
      <pc:docMkLst>
        <pc:docMk/>
      </pc:docMkLst>
      <pc:sldChg chg="modSp mod">
        <pc:chgData name="Akira Ouchi" userId="3da18b59e1d60f73" providerId="LiveId" clId="{C99AD3AB-F44A-4646-8D6E-4C0A93682AEC}" dt="2024-07-12T05:58:51.263" v="0" actId="20577"/>
        <pc:sldMkLst>
          <pc:docMk/>
          <pc:sldMk cId="978796953" sldId="25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811128-71D7-4B27-929C-44BEBF665BD5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7D4F56-7F9F-4B04-A4C0-B0589A75D3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2353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BDE2BD-1CE0-6045-E301-CCB7170C49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9A2D957-4FA2-EC91-A1D4-64F9EABD7A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B9044B-E7C9-19CC-4D30-43BF5E433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6CAE3F-B2AE-6115-B53A-A043098B1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3A2845-D4B6-2B78-5D62-C09B921CA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282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DBD759-21BA-C364-1D1A-4EC9A115F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526E5C-160A-1F1C-EE2B-C61786051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D1E6B7-0319-6925-10D4-A91140AA1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0C8ABF-AD90-D3DE-C1DD-DF8663B6E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7AF6D9-E8A6-2D67-721A-8F1DEF006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593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C9F6456-4EA6-CF30-F624-FF0A1FEB8F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EACF61-0933-F9D0-E6F5-932D18C69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D3CF8FE-3980-9488-E274-900450640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96F038-600F-8374-2E18-11A0668C2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61BD97-375D-6777-C4F6-0B7C32E91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8995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5A20A6-A424-ED56-E9EA-4BF432E1F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957EEE-E15B-9F61-7BF1-57A5D5795A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C9BE29-FD3F-6219-E01D-8C261B308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48BDE6-E8F8-325A-1CF6-010967E13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5B2D25-2598-62F6-68F9-5C1351AA9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60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697EC4-05B9-E85E-28FB-08741F801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F0B3EA-6B33-512C-CEB0-8922116197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630495-F2A3-87A2-7E09-26F946D8A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1DA0E0-BB9C-CF48-9CC1-748B7A2E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38F3A1-D485-5CB6-96CB-3B85695E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050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9C08A7-60D2-8691-841B-813B1CC0C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D4515A7-CF93-49A1-3CC7-4B4F79A7B6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8FFFF6-FBC9-44A6-5022-2D4DC48344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6B8E1D-8DB5-0D44-5063-EDDDA0DA1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FA54B9B-ED14-B1BC-799C-42407891F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69C050-3239-35DB-2DB9-358EF308C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33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73156-CC01-16A9-B4F9-E5DA4731D7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D22BE4-6C91-F310-EF07-4F4332693D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45E6F8-7DB2-1F62-7F49-810323CDA0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06C8A4A-9915-9556-45E0-2AF1648FD5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9D9FCF9-AAA0-70A2-53CF-95EC67F21A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8296F6-9BE7-446F-707B-93E4A777EE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AB0578-7B6B-7DA9-B003-01AB82898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C3A955A-86EF-4D72-A546-464B3FC4B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658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17CF12-5892-7F38-1369-272748354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9C3720C-93F5-BAC7-B486-DA76CF37F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2110B6-39F5-DFBD-E114-5AA222BB5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C16756E-77D0-A53A-CA72-FF917C677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69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FE2EBD9-74F5-50B0-3867-4AB51B9E0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175489-1B30-D6D1-2FD6-6B37A2F67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B556469-32DE-36D1-7CB2-777572006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851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BD3CB-499B-4748-72B1-5A6E71B20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21888A-A65B-F645-E59C-9F18775DB5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BD0AA-BC28-775D-C64A-FCBEDBE74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5B41E21-D8E2-FD0F-CDB0-7A93293BA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7E7FBD-61A6-73BB-DAA2-94EB185EA1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5019B2E-E404-A0C5-501B-A88BEA7C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727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E0F45C-FCE9-FB2B-F2DE-A0E1EF358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EEA8F11-DFB4-531E-F19E-F7C8D5C985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20309F-E54E-9F3F-8B01-FC7DD35F3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B9AE2BD-270B-A1AF-2505-370301CD6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312380-B8DB-8AC4-5020-5307DD316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9372365-4DEF-A63E-D2FA-EB495A61A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202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5B3F53C-2662-436C-F253-31A401947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03F3BA-383F-FC3F-101D-350935744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578D5-ECB4-0CDB-FE88-4AD74BE228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D7BCE1-D3AA-4E6E-A95D-047D681BD1D7}" type="datetimeFigureOut">
              <a:rPr kumimoji="1" lang="ja-JP" altLang="en-US" smtClean="0"/>
              <a:t>2025/3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C32F6F-A946-B5CB-D110-D8EC247BCC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9DF4C1-0B32-A0AE-3E89-70688011A6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5A520F-0705-44EC-885F-CFFF88A8BD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856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21">
            <a:extLst>
              <a:ext uri="{FF2B5EF4-FFF2-40B4-BE49-F238E27FC236}">
                <a16:creationId xmlns:a16="http://schemas.microsoft.com/office/drawing/2014/main" id="{ED959D16-1079-99D4-E1A3-CE4317D5DDB8}"/>
              </a:ext>
            </a:extLst>
          </p:cNvPr>
          <p:cNvSpPr txBox="1"/>
          <p:nvPr/>
        </p:nvSpPr>
        <p:spPr>
          <a:xfrm>
            <a:off x="345831" y="6083051"/>
            <a:ext cx="115003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Bef>
                <a:spcPts val="600"/>
              </a:spcBef>
            </a:pP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idence of lymph node metastasis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rom 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ight-sided colon cancers by </a:t>
            </a:r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umor location.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4F0A2B8-FA26-2942-667E-034E0E99872E}"/>
              </a:ext>
            </a:extLst>
          </p:cNvPr>
          <p:cNvSpPr txBox="1"/>
          <p:nvPr/>
        </p:nvSpPr>
        <p:spPr>
          <a:xfrm>
            <a:off x="401756" y="986010"/>
            <a:ext cx="1160895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ecum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3F4D9DD-ED1E-725B-A0C5-87676783FDCD}"/>
              </a:ext>
            </a:extLst>
          </p:cNvPr>
          <p:cNvSpPr txBox="1"/>
          <p:nvPr/>
        </p:nvSpPr>
        <p:spPr>
          <a:xfrm>
            <a:off x="4174068" y="981997"/>
            <a:ext cx="2174313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scending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2A976BA-D3E9-837A-61D3-7F094DA206A4}"/>
              </a:ext>
            </a:extLst>
          </p:cNvPr>
          <p:cNvSpPr txBox="1"/>
          <p:nvPr/>
        </p:nvSpPr>
        <p:spPr>
          <a:xfrm>
            <a:off x="7942420" y="986832"/>
            <a:ext cx="2293961" cy="4001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lang="ja-JP" altLang="en-US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・</a:t>
            </a:r>
            <a:r>
              <a:rPr lang="en-US" altLang="ja-JP" sz="20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ansverse colon</a:t>
            </a:r>
            <a:endParaRPr lang="ja-JP" altLang="en-US" sz="20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D9D15A3B-33B2-3177-0721-5CC9F603F8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795" y="1585666"/>
            <a:ext cx="3839906" cy="4010128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1A0E6759-B046-1BEB-7CD8-5E2CB7C9B8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76047" y="1595336"/>
            <a:ext cx="3839906" cy="4010128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F818365B-7D12-A1F7-CA62-3D5F50F74A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36479" y="1595336"/>
            <a:ext cx="3843864" cy="4010128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A109CD3-BB2F-0D5A-AB25-59EA81C202BA}"/>
              </a:ext>
            </a:extLst>
          </p:cNvPr>
          <p:cNvSpPr txBox="1"/>
          <p:nvPr/>
        </p:nvSpPr>
        <p:spPr>
          <a:xfrm>
            <a:off x="10793850" y="4651356"/>
            <a:ext cx="769763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% &lt;</a:t>
            </a:r>
          </a:p>
          <a:p>
            <a:r>
              <a:rPr kumimoji="1" lang="en-US" altLang="ja-JP" sz="1400" b="1" dirty="0">
                <a:solidFill>
                  <a:srgbClr val="C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</a:t>
            </a:r>
            <a:r>
              <a:rPr kumimoji="1" lang="ja-JP" altLang="en-US" sz="1400" b="1" dirty="0">
                <a:solidFill>
                  <a:srgbClr val="C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～</a:t>
            </a:r>
            <a:r>
              <a:rPr kumimoji="1" lang="en-US" altLang="ja-JP" sz="1400" b="1" dirty="0">
                <a:solidFill>
                  <a:srgbClr val="C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%</a:t>
            </a:r>
          </a:p>
          <a:p>
            <a:r>
              <a:rPr lang="en-US" altLang="ja-JP" sz="1400" b="1" dirty="0">
                <a:solidFill>
                  <a:srgbClr val="660033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r>
              <a:rPr lang="ja-JP" altLang="en-US" sz="1400" b="1" dirty="0">
                <a:solidFill>
                  <a:srgbClr val="660033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～</a:t>
            </a:r>
            <a:r>
              <a:rPr lang="en-US" altLang="ja-JP" sz="1400" b="1" dirty="0">
                <a:solidFill>
                  <a:srgbClr val="660033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%</a:t>
            </a:r>
          </a:p>
          <a:p>
            <a:r>
              <a:rPr lang="en-US" altLang="ja-JP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&lt; </a:t>
            </a:r>
            <a:r>
              <a:rPr kumimoji="1" lang="en-US" altLang="ja-JP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%</a:t>
            </a:r>
            <a:endParaRPr kumimoji="1" lang="ja-JP" altLang="en-US" sz="1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0399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38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kira Ouchi</dc:creator>
  <cp:lastModifiedBy>Akira Ouchi</cp:lastModifiedBy>
  <cp:revision>4</cp:revision>
  <dcterms:created xsi:type="dcterms:W3CDTF">2024-07-12T05:48:55Z</dcterms:created>
  <dcterms:modified xsi:type="dcterms:W3CDTF">2025-03-11T12:01:42Z</dcterms:modified>
</cp:coreProperties>
</file>